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0819-F9A6-43ED-9902-725E14990EE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150D3-260E-4098-8F6E-0A091C8310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0819-F9A6-43ED-9902-725E14990EE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150D3-260E-4098-8F6E-0A091C8310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0819-F9A6-43ED-9902-725E14990EE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150D3-260E-4098-8F6E-0A091C8310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0819-F9A6-43ED-9902-725E14990EE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150D3-260E-4098-8F6E-0A091C8310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0819-F9A6-43ED-9902-725E14990EE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150D3-260E-4098-8F6E-0A091C8310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0819-F9A6-43ED-9902-725E14990EE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150D3-260E-4098-8F6E-0A091C8310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0819-F9A6-43ED-9902-725E14990EE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150D3-260E-4098-8F6E-0A091C8310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0819-F9A6-43ED-9902-725E14990EE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150D3-260E-4098-8F6E-0A091C8310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0819-F9A6-43ED-9902-725E14990EE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150D3-260E-4098-8F6E-0A091C8310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0819-F9A6-43ED-9902-725E14990EE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150D3-260E-4098-8F6E-0A091C8310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C0819-F9A6-43ED-9902-725E14990EE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150D3-260E-4098-8F6E-0A091C8310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3C0819-F9A6-43ED-9902-725E14990EEC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A150D3-260E-4098-8F6E-0A091C8310F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441132387"/>
              </p:ext>
            </p:extLst>
          </p:nvPr>
        </p:nvGraphicFramePr>
        <p:xfrm>
          <a:off x="457200" y="1066802"/>
          <a:ext cx="8305800" cy="425514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5073"/>
                <a:gridCol w="6040582"/>
                <a:gridCol w="679565"/>
                <a:gridCol w="830580"/>
              </a:tblGrid>
              <a:tr h="448515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Network number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Network details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Score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Focus molecules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1976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Cancer,</a:t>
                      </a:r>
                      <a:r>
                        <a:rPr lang="en-US" sz="1000" baseline="0" dirty="0" smtClean="0">
                          <a:latin typeface="Arial" pitchFamily="34" charset="0"/>
                          <a:cs typeface="Arial" pitchFamily="34" charset="0"/>
                        </a:rPr>
                        <a:t> reproductive system diseases, lipid metabolism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8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2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1976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Gene expression, cell signaling,</a:t>
                      </a:r>
                      <a:r>
                        <a:rPr lang="en-US" sz="1000" baseline="0" dirty="0" smtClean="0">
                          <a:latin typeface="Arial" pitchFamily="34" charset="0"/>
                          <a:cs typeface="Arial" pitchFamily="34" charset="0"/>
                        </a:rPr>
                        <a:t> small molecule biochemistry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4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1976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Cancer, organ morphology, reproductive system development and function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2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1976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Cellular assembly and organization, cellular compromise, DNA replication, recombination and repair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1976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Carbohydrate metabolism, molecular transport, small molecule biochemistry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1976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Lipid metabolism, molecular transport, small molecule biochemistry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1976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Endocrine system development and function, small molecule biochemistry, drug</a:t>
                      </a:r>
                      <a:r>
                        <a:rPr lang="en-US" sz="1000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metabolism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smtClean="0"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4851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Cell cycle, renal and urological system development and function, connective</a:t>
                      </a:r>
                      <a:r>
                        <a:rPr lang="en-US" sz="1000" baseline="0" dirty="0" smtClean="0">
                          <a:latin typeface="Arial" pitchFamily="34" charset="0"/>
                          <a:cs typeface="Arial" pitchFamily="34" charset="0"/>
                        </a:rPr>
                        <a:t> tissue development and function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19764">
                <a:tc>
                  <a:txBody>
                    <a:bodyPr/>
                    <a:lstStyle/>
                    <a:p>
                      <a:pPr algn="ctr"/>
                      <a:r>
                        <a:rPr lang="en-US" sz="100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Gene expression, cardiovascular system development and function, cell to cell signaling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457200" y="685800"/>
            <a:ext cx="769154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Supplemental Table 4. Networks involved during E</a:t>
            </a:r>
            <a:r>
              <a:rPr lang="en-US" sz="1000" b="1" baseline="-25000" dirty="0" smtClean="0">
                <a:latin typeface="Arial" pitchFamily="34" charset="0"/>
                <a:cs typeface="Arial" pitchFamily="34" charset="0"/>
              </a:rPr>
              <a:t>2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replacement (D16, 96 h AI+E</a:t>
            </a:r>
            <a:r>
              <a:rPr lang="en-US" sz="1000" b="1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) using IPA software </a:t>
            </a:r>
            <a:endParaRPr lang="en-IN" sz="1000" b="1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54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iis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uresh</dc:creator>
  <cp:lastModifiedBy>user</cp:lastModifiedBy>
  <cp:revision>2</cp:revision>
  <dcterms:created xsi:type="dcterms:W3CDTF">2016-02-22T05:09:12Z</dcterms:created>
  <dcterms:modified xsi:type="dcterms:W3CDTF">2016-02-22T10:33:00Z</dcterms:modified>
</cp:coreProperties>
</file>